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Ex1.xml" ContentType="application/vnd.ms-office.chartex+xml"/>
  <Override PartName="/ppt/charts/style3.xml" ContentType="application/vnd.ms-office.chartstyle+xml"/>
  <Override PartName="/ppt/charts/colors3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9" r:id="rId2"/>
    <p:sldId id="262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97" userDrawn="1">
          <p15:clr>
            <a:srgbClr val="A4A3A4"/>
          </p15:clr>
        </p15:guide>
        <p15:guide id="2" pos="211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621"/>
    <p:restoredTop sz="96327"/>
  </p:normalViewPr>
  <p:slideViewPr>
    <p:cSldViewPr snapToGrid="0" snapToObjects="1" showGuides="1">
      <p:cViewPr varScale="1">
        <p:scale>
          <a:sx n="82" d="100"/>
          <a:sy n="82" d="100"/>
        </p:scale>
        <p:origin x="3328" y="184"/>
      </p:cViewPr>
      <p:guideLst>
        <p:guide orient="horz" pos="3097"/>
        <p:guide pos="211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ouzai Yusuke" userId="e7348b3eb85b30eb" providerId="LiveId" clId="{D7854A5D-277D-5649-9C8E-CD9325CB77FD}"/>
    <pc:docChg chg="modSld">
      <pc:chgData name="Kouzai Yusuke" userId="e7348b3eb85b30eb" providerId="LiveId" clId="{D7854A5D-277D-5649-9C8E-CD9325CB77FD}" dt="2022-05-01T23:30:08.693" v="9" actId="114"/>
      <pc:docMkLst>
        <pc:docMk/>
      </pc:docMkLst>
      <pc:sldChg chg="modSp mod">
        <pc:chgData name="Kouzai Yusuke" userId="e7348b3eb85b30eb" providerId="LiveId" clId="{D7854A5D-277D-5649-9C8E-CD9325CB77FD}" dt="2022-05-01T23:29:17.155" v="2" actId="114"/>
        <pc:sldMkLst>
          <pc:docMk/>
          <pc:sldMk cId="323356021" sldId="259"/>
        </pc:sldMkLst>
        <pc:spChg chg="mod">
          <ac:chgData name="Kouzai Yusuke" userId="e7348b3eb85b30eb" providerId="LiveId" clId="{D7854A5D-277D-5649-9C8E-CD9325CB77FD}" dt="2022-05-01T23:29:17.155" v="2" actId="114"/>
          <ac:spMkLst>
            <pc:docMk/>
            <pc:sldMk cId="323356021" sldId="259"/>
            <ac:spMk id="6" creationId="{9BD10BC9-1315-3D41-9DDD-B3DA60171AB5}"/>
          </ac:spMkLst>
        </pc:spChg>
      </pc:sldChg>
      <pc:sldChg chg="modSp mod">
        <pc:chgData name="Kouzai Yusuke" userId="e7348b3eb85b30eb" providerId="LiveId" clId="{D7854A5D-277D-5649-9C8E-CD9325CB77FD}" dt="2022-05-01T23:30:08.693" v="9" actId="114"/>
        <pc:sldMkLst>
          <pc:docMk/>
          <pc:sldMk cId="1784612854" sldId="262"/>
        </pc:sldMkLst>
        <pc:spChg chg="mod">
          <ac:chgData name="Kouzai Yusuke" userId="e7348b3eb85b30eb" providerId="LiveId" clId="{D7854A5D-277D-5649-9C8E-CD9325CB77FD}" dt="2022-05-01T23:30:08.693" v="9" actId="114"/>
          <ac:spMkLst>
            <pc:docMk/>
            <pc:sldMk cId="1784612854" sldId="262"/>
            <ac:spMk id="2" creationId="{CF8B34BF-BEDF-064E-B27D-D4F7DEC734EE}"/>
          </ac:spMkLst>
        </pc:spChg>
      </pc:sldChg>
    </pc:docChg>
  </pc:docChgLst>
  <pc:docChgLst>
    <pc:chgData name="Kouzai Yusuke" userId="e7348b3eb85b30eb" providerId="LiveId" clId="{07C39C3B-2879-7A4B-ABA3-73FD900C8791}"/>
    <pc:docChg chg="modSld">
      <pc:chgData name="Kouzai Yusuke" userId="e7348b3eb85b30eb" providerId="LiveId" clId="{07C39C3B-2879-7A4B-ABA3-73FD900C8791}" dt="2022-05-24T08:55:36.505" v="1" actId="58"/>
      <pc:docMkLst>
        <pc:docMk/>
      </pc:docMkLst>
      <pc:sldChg chg="modSp mod">
        <pc:chgData name="Kouzai Yusuke" userId="e7348b3eb85b30eb" providerId="LiveId" clId="{07C39C3B-2879-7A4B-ABA3-73FD900C8791}" dt="2022-05-24T08:55:36.505" v="1" actId="58"/>
        <pc:sldMkLst>
          <pc:docMk/>
          <pc:sldMk cId="1784612854" sldId="262"/>
        </pc:sldMkLst>
        <pc:spChg chg="mod">
          <ac:chgData name="Kouzai Yusuke" userId="e7348b3eb85b30eb" providerId="LiveId" clId="{07C39C3B-2879-7A4B-ABA3-73FD900C8791}" dt="2022-05-24T08:55:36.505" v="1" actId="58"/>
          <ac:spMkLst>
            <pc:docMk/>
            <pc:sldMk cId="1784612854" sldId="262"/>
            <ac:spMk id="2" creationId="{CF8B34BF-BEDF-064E-B27D-D4F7DEC734EE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e7348b3eb85b30eb/BB1/Figure3%20toxoflavi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e7348b3eb85b30eb/BB1/Figure3%20toxoflavin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microsoft.com/office/2011/relationships/chartStyle" Target="style3.xml"/><Relationship Id="rId1" Type="http://schemas.openxmlformats.org/officeDocument/2006/relationships/oleObject" Target="https://d.docs.live.net/e7348b3eb85b30eb/BB1/220209BB1only_7dpi_soi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100" dirty="0"/>
              <a:t>NPB6 (</a:t>
            </a:r>
            <a:r>
              <a:rPr lang="en-US" sz="1100" dirty="0" err="1"/>
              <a:t>Herbaspirillum</a:t>
            </a:r>
            <a:r>
              <a:rPr lang="en-US" sz="1100" dirty="0"/>
              <a:t>)</a:t>
            </a:r>
            <a:endParaRPr lang="ja-JP" sz="1100"/>
          </a:p>
        </c:rich>
      </c:tx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scatterChart>
        <c:scatterStyle val="smoothMarker"/>
        <c:varyColors val="0"/>
        <c:ser>
          <c:idx val="0"/>
          <c:order val="0"/>
          <c:tx>
            <c:strRef>
              <c:f>'[Figure3 toxoflavin.xlsx]NPB6_Herbaspirillum'!$B$9</c:f>
              <c:strCache>
                <c:ptCount val="1"/>
                <c:pt idx="0">
                  <c:v>-Tox</c:v>
                </c:pt>
              </c:strCache>
            </c:strRef>
          </c:tx>
          <c:spPr>
            <a:ln w="158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7"/>
            <c:spPr>
              <a:pattFill prst="pct50">
                <a:fgClr>
                  <a:schemeClr val="tx1"/>
                </a:fgClr>
                <a:bgClr>
                  <a:schemeClr val="bg1"/>
                </a:bgClr>
              </a:patt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Figure3 toxoflavin.xlsx]NPB6_Herbaspirillum'!$C$12:$AG$12</c:f>
                <c:numCache>
                  <c:formatCode>General</c:formatCode>
                  <c:ptCount val="31"/>
                  <c:pt idx="0">
                    <c:v>2.6512040297005704E-3</c:v>
                  </c:pt>
                  <c:pt idx="1">
                    <c:v>2.6280544179301886E-3</c:v>
                  </c:pt>
                  <c:pt idx="2">
                    <c:v>2.6712465042560275E-3</c:v>
                  </c:pt>
                  <c:pt idx="3">
                    <c:v>1.5720896916783831E-2</c:v>
                  </c:pt>
                  <c:pt idx="4">
                    <c:v>1.4905700703703144E-2</c:v>
                  </c:pt>
                  <c:pt idx="5">
                    <c:v>2.6599917332083389E-2</c:v>
                  </c:pt>
                  <c:pt idx="6">
                    <c:v>6.8794383870084894E-3</c:v>
                  </c:pt>
                  <c:pt idx="7">
                    <c:v>9.0415098196333955E-3</c:v>
                  </c:pt>
                  <c:pt idx="8">
                    <c:v>2.5516398262163249E-2</c:v>
                  </c:pt>
                  <c:pt idx="9">
                    <c:v>5.1526449250112447E-2</c:v>
                  </c:pt>
                  <c:pt idx="10">
                    <c:v>3.69075707904125E-2</c:v>
                  </c:pt>
                  <c:pt idx="11">
                    <c:v>3.7390996825615433E-2</c:v>
                  </c:pt>
                  <c:pt idx="12">
                    <c:v>3.8811194225002323E-2</c:v>
                  </c:pt>
                  <c:pt idx="13">
                    <c:v>4.4640518512978032E-2</c:v>
                  </c:pt>
                  <c:pt idx="14">
                    <c:v>4.5047336129383553E-2</c:v>
                  </c:pt>
                  <c:pt idx="15">
                    <c:v>4.2709798866633189E-2</c:v>
                  </c:pt>
                  <c:pt idx="16">
                    <c:v>4.676568598384076E-2</c:v>
                  </c:pt>
                  <c:pt idx="17">
                    <c:v>4.2580360913808873E-2</c:v>
                  </c:pt>
                  <c:pt idx="18">
                    <c:v>4.6229457305103236E-2</c:v>
                  </c:pt>
                  <c:pt idx="19">
                    <c:v>4.7481857462928004E-2</c:v>
                  </c:pt>
                  <c:pt idx="20">
                    <c:v>4.6016400584004788E-2</c:v>
                  </c:pt>
                  <c:pt idx="21">
                    <c:v>4.6917697935624725E-2</c:v>
                  </c:pt>
                  <c:pt idx="22">
                    <c:v>4.3373226442068161E-2</c:v>
                  </c:pt>
                  <c:pt idx="23">
                    <c:v>4.5930195679100165E-2</c:v>
                  </c:pt>
                  <c:pt idx="24">
                    <c:v>4.0356644471565409E-2</c:v>
                  </c:pt>
                  <c:pt idx="25">
                    <c:v>3.15350530685383E-2</c:v>
                  </c:pt>
                  <c:pt idx="26">
                    <c:v>2.8239127143753356E-2</c:v>
                  </c:pt>
                  <c:pt idx="27">
                    <c:v>3.4365125363877334E-2</c:v>
                  </c:pt>
                  <c:pt idx="28">
                    <c:v>3.5897726987120432E-2</c:v>
                  </c:pt>
                  <c:pt idx="29">
                    <c:v>4.1518914581283678E-2</c:v>
                  </c:pt>
                  <c:pt idx="30">
                    <c:v>3.7891276396489475E-2</c:v>
                  </c:pt>
                </c:numCache>
              </c:numRef>
            </c:plus>
            <c:minus>
              <c:numRef>
                <c:f>'[Figure3 toxoflavin.xlsx]NPB6_Herbaspirillum'!$C$12:$AG$12</c:f>
                <c:numCache>
                  <c:formatCode>General</c:formatCode>
                  <c:ptCount val="31"/>
                  <c:pt idx="0">
                    <c:v>2.6512040297005704E-3</c:v>
                  </c:pt>
                  <c:pt idx="1">
                    <c:v>2.6280544179301886E-3</c:v>
                  </c:pt>
                  <c:pt idx="2">
                    <c:v>2.6712465042560275E-3</c:v>
                  </c:pt>
                  <c:pt idx="3">
                    <c:v>1.5720896916783831E-2</c:v>
                  </c:pt>
                  <c:pt idx="4">
                    <c:v>1.4905700703703144E-2</c:v>
                  </c:pt>
                  <c:pt idx="5">
                    <c:v>2.6599917332083389E-2</c:v>
                  </c:pt>
                  <c:pt idx="6">
                    <c:v>6.8794383870084894E-3</c:v>
                  </c:pt>
                  <c:pt idx="7">
                    <c:v>9.0415098196333955E-3</c:v>
                  </c:pt>
                  <c:pt idx="8">
                    <c:v>2.5516398262163249E-2</c:v>
                  </c:pt>
                  <c:pt idx="9">
                    <c:v>5.1526449250112447E-2</c:v>
                  </c:pt>
                  <c:pt idx="10">
                    <c:v>3.69075707904125E-2</c:v>
                  </c:pt>
                  <c:pt idx="11">
                    <c:v>3.7390996825615433E-2</c:v>
                  </c:pt>
                  <c:pt idx="12">
                    <c:v>3.8811194225002323E-2</c:v>
                  </c:pt>
                  <c:pt idx="13">
                    <c:v>4.4640518512978032E-2</c:v>
                  </c:pt>
                  <c:pt idx="14">
                    <c:v>4.5047336129383553E-2</c:v>
                  </c:pt>
                  <c:pt idx="15">
                    <c:v>4.2709798866633189E-2</c:v>
                  </c:pt>
                  <c:pt idx="16">
                    <c:v>4.676568598384076E-2</c:v>
                  </c:pt>
                  <c:pt idx="17">
                    <c:v>4.2580360913808873E-2</c:v>
                  </c:pt>
                  <c:pt idx="18">
                    <c:v>4.6229457305103236E-2</c:v>
                  </c:pt>
                  <c:pt idx="19">
                    <c:v>4.7481857462928004E-2</c:v>
                  </c:pt>
                  <c:pt idx="20">
                    <c:v>4.6016400584004788E-2</c:v>
                  </c:pt>
                  <c:pt idx="21">
                    <c:v>4.6917697935624725E-2</c:v>
                  </c:pt>
                  <c:pt idx="22">
                    <c:v>4.3373226442068161E-2</c:v>
                  </c:pt>
                  <c:pt idx="23">
                    <c:v>4.5930195679100165E-2</c:v>
                  </c:pt>
                  <c:pt idx="24">
                    <c:v>4.0356644471565409E-2</c:v>
                  </c:pt>
                  <c:pt idx="25">
                    <c:v>3.15350530685383E-2</c:v>
                  </c:pt>
                  <c:pt idx="26">
                    <c:v>2.8239127143753356E-2</c:v>
                  </c:pt>
                  <c:pt idx="27">
                    <c:v>3.4365125363877334E-2</c:v>
                  </c:pt>
                  <c:pt idx="28">
                    <c:v>3.5897726987120432E-2</c:v>
                  </c:pt>
                  <c:pt idx="29">
                    <c:v>4.1518914581283678E-2</c:v>
                  </c:pt>
                  <c:pt idx="30">
                    <c:v>3.789127639648947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yVal>
            <c:numRef>
              <c:f>'[Figure3 toxoflavin.xlsx]NPB6_Herbaspirillum'!$C$9:$AG$9</c:f>
              <c:numCache>
                <c:formatCode>General</c:formatCode>
                <c:ptCount val="31"/>
                <c:pt idx="0">
                  <c:v>9.556666513284047E-2</c:v>
                </c:pt>
                <c:pt idx="1">
                  <c:v>9.4999998807907104E-2</c:v>
                </c:pt>
                <c:pt idx="2">
                  <c:v>9.6666666368643447E-2</c:v>
                </c:pt>
                <c:pt idx="3">
                  <c:v>0.11380000164111455</c:v>
                </c:pt>
                <c:pt idx="4">
                  <c:v>0.11799999823172887</c:v>
                </c:pt>
                <c:pt idx="5">
                  <c:v>0.14056666692097983</c:v>
                </c:pt>
                <c:pt idx="6">
                  <c:v>0.15929999947547913</c:v>
                </c:pt>
                <c:pt idx="7">
                  <c:v>0.179666668176651</c:v>
                </c:pt>
                <c:pt idx="8">
                  <c:v>0.22649999459584555</c:v>
                </c:pt>
                <c:pt idx="9">
                  <c:v>0.31923333803812665</c:v>
                </c:pt>
                <c:pt idx="10">
                  <c:v>0.3621666630109151</c:v>
                </c:pt>
                <c:pt idx="11">
                  <c:v>0.40189999341964722</c:v>
                </c:pt>
                <c:pt idx="12">
                  <c:v>0.43943332632382709</c:v>
                </c:pt>
                <c:pt idx="13">
                  <c:v>0.4564666748046875</c:v>
                </c:pt>
                <c:pt idx="14">
                  <c:v>0.47433333595593768</c:v>
                </c:pt>
                <c:pt idx="15">
                  <c:v>0.489600012699763</c:v>
                </c:pt>
                <c:pt idx="16">
                  <c:v>0.49236667156219482</c:v>
                </c:pt>
                <c:pt idx="17">
                  <c:v>0.49540000160535175</c:v>
                </c:pt>
                <c:pt idx="18">
                  <c:v>0.49186666806538898</c:v>
                </c:pt>
                <c:pt idx="19">
                  <c:v>0.49129999677340191</c:v>
                </c:pt>
                <c:pt idx="20">
                  <c:v>0.48513333996136981</c:v>
                </c:pt>
                <c:pt idx="21">
                  <c:v>0.482833335796992</c:v>
                </c:pt>
                <c:pt idx="22">
                  <c:v>0.47713333368301392</c:v>
                </c:pt>
                <c:pt idx="23">
                  <c:v>0.47506667176882428</c:v>
                </c:pt>
                <c:pt idx="24">
                  <c:v>0.4699999988079071</c:v>
                </c:pt>
                <c:pt idx="25">
                  <c:v>0.46339998642603558</c:v>
                </c:pt>
                <c:pt idx="26">
                  <c:v>0.46426665782928467</c:v>
                </c:pt>
                <c:pt idx="27">
                  <c:v>0.46503333250681561</c:v>
                </c:pt>
                <c:pt idx="28">
                  <c:v>0.4659000039100647</c:v>
                </c:pt>
                <c:pt idx="29">
                  <c:v>0.48840000232060748</c:v>
                </c:pt>
                <c:pt idx="30">
                  <c:v>0.4697333375612894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6610-1B47-8CCD-C0C2BCC3DD47}"/>
            </c:ext>
          </c:extLst>
        </c:ser>
        <c:ser>
          <c:idx val="1"/>
          <c:order val="1"/>
          <c:tx>
            <c:strRef>
              <c:f>'[Figure3 toxoflavin.xlsx]NPB6_Herbaspirillum'!$B$10</c:f>
              <c:strCache>
                <c:ptCount val="1"/>
                <c:pt idx="0">
                  <c:v>+Tox</c:v>
                </c:pt>
              </c:strCache>
            </c:strRef>
          </c:tx>
          <c:spPr>
            <a:ln w="15875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Figure3 toxoflavin.xlsx]NPB6_Herbaspirillum'!$C$13:$AG$13</c:f>
                <c:numCache>
                  <c:formatCode>General</c:formatCode>
                  <c:ptCount val="31"/>
                  <c:pt idx="0">
                    <c:v>6.1282571406052696E-4</c:v>
                  </c:pt>
                  <c:pt idx="1">
                    <c:v>1.6062371991914736E-3</c:v>
                  </c:pt>
                  <c:pt idx="2">
                    <c:v>1.1264492027912444E-3</c:v>
                  </c:pt>
                  <c:pt idx="3">
                    <c:v>1.3021351075115249E-3</c:v>
                  </c:pt>
                  <c:pt idx="4">
                    <c:v>1.2754070436334819E-3</c:v>
                  </c:pt>
                  <c:pt idx="5">
                    <c:v>9.4633649474924286E-4</c:v>
                  </c:pt>
                  <c:pt idx="6">
                    <c:v>1.4445297791367202E-3</c:v>
                  </c:pt>
                  <c:pt idx="7">
                    <c:v>1.1343114843905572E-3</c:v>
                  </c:pt>
                  <c:pt idx="8">
                    <c:v>1.2832249559543163E-3</c:v>
                  </c:pt>
                  <c:pt idx="9">
                    <c:v>1.9304596910387102E-3</c:v>
                  </c:pt>
                  <c:pt idx="10">
                    <c:v>1.0498659330906274E-3</c:v>
                  </c:pt>
                  <c:pt idx="11">
                    <c:v>9.1043266948684603E-4</c:v>
                  </c:pt>
                  <c:pt idx="12">
                    <c:v>1.3589211167316152E-3</c:v>
                  </c:pt>
                  <c:pt idx="13">
                    <c:v>1.3888436342288917E-3</c:v>
                  </c:pt>
                  <c:pt idx="14">
                    <c:v>2.0805964208987799E-3</c:v>
                  </c:pt>
                  <c:pt idx="15">
                    <c:v>2.1853043213695728E-3</c:v>
                  </c:pt>
                  <c:pt idx="16">
                    <c:v>2.361261541443086E-3</c:v>
                  </c:pt>
                  <c:pt idx="17">
                    <c:v>2.3328574784158254E-3</c:v>
                  </c:pt>
                  <c:pt idx="18">
                    <c:v>1.9955505351257159E-3</c:v>
                  </c:pt>
                  <c:pt idx="19">
                    <c:v>1.8624962868544911E-3</c:v>
                  </c:pt>
                  <c:pt idx="20">
                    <c:v>1.915434655058696E-3</c:v>
                  </c:pt>
                  <c:pt idx="21">
                    <c:v>1.8061626147756649E-3</c:v>
                  </c:pt>
                  <c:pt idx="22">
                    <c:v>2.206556623439685E-3</c:v>
                  </c:pt>
                  <c:pt idx="23">
                    <c:v>2.8288182751047067E-3</c:v>
                  </c:pt>
                  <c:pt idx="24">
                    <c:v>2.9799323234940755E-3</c:v>
                  </c:pt>
                  <c:pt idx="25">
                    <c:v>3.0554152472301575E-3</c:v>
                  </c:pt>
                  <c:pt idx="26">
                    <c:v>2.4689171344722642E-3</c:v>
                  </c:pt>
                  <c:pt idx="27">
                    <c:v>2.5460191204695181E-3</c:v>
                  </c:pt>
                  <c:pt idx="28">
                    <c:v>2.5302609722054345E-3</c:v>
                  </c:pt>
                  <c:pt idx="29">
                    <c:v>2.9009550655379121E-3</c:v>
                  </c:pt>
                  <c:pt idx="30">
                    <c:v>2.7157985394762299E-3</c:v>
                  </c:pt>
                </c:numCache>
              </c:numRef>
            </c:plus>
            <c:minus>
              <c:numRef>
                <c:f>'[Figure3 toxoflavin.xlsx]NPB6_Herbaspirillum'!$C$13:$AG$13</c:f>
                <c:numCache>
                  <c:formatCode>General</c:formatCode>
                  <c:ptCount val="31"/>
                  <c:pt idx="0">
                    <c:v>6.1282571406052696E-4</c:v>
                  </c:pt>
                  <c:pt idx="1">
                    <c:v>1.6062371991914736E-3</c:v>
                  </c:pt>
                  <c:pt idx="2">
                    <c:v>1.1264492027912444E-3</c:v>
                  </c:pt>
                  <c:pt idx="3">
                    <c:v>1.3021351075115249E-3</c:v>
                  </c:pt>
                  <c:pt idx="4">
                    <c:v>1.2754070436334819E-3</c:v>
                  </c:pt>
                  <c:pt idx="5">
                    <c:v>9.4633649474924286E-4</c:v>
                  </c:pt>
                  <c:pt idx="6">
                    <c:v>1.4445297791367202E-3</c:v>
                  </c:pt>
                  <c:pt idx="7">
                    <c:v>1.1343114843905572E-3</c:v>
                  </c:pt>
                  <c:pt idx="8">
                    <c:v>1.2832249559543163E-3</c:v>
                  </c:pt>
                  <c:pt idx="9">
                    <c:v>1.9304596910387102E-3</c:v>
                  </c:pt>
                  <c:pt idx="10">
                    <c:v>1.0498659330906274E-3</c:v>
                  </c:pt>
                  <c:pt idx="11">
                    <c:v>9.1043266948684603E-4</c:v>
                  </c:pt>
                  <c:pt idx="12">
                    <c:v>1.3589211167316152E-3</c:v>
                  </c:pt>
                  <c:pt idx="13">
                    <c:v>1.3888436342288917E-3</c:v>
                  </c:pt>
                  <c:pt idx="14">
                    <c:v>2.0805964208987799E-3</c:v>
                  </c:pt>
                  <c:pt idx="15">
                    <c:v>2.1853043213695728E-3</c:v>
                  </c:pt>
                  <c:pt idx="16">
                    <c:v>2.361261541443086E-3</c:v>
                  </c:pt>
                  <c:pt idx="17">
                    <c:v>2.3328574784158254E-3</c:v>
                  </c:pt>
                  <c:pt idx="18">
                    <c:v>1.9955505351257159E-3</c:v>
                  </c:pt>
                  <c:pt idx="19">
                    <c:v>1.8624962868544911E-3</c:v>
                  </c:pt>
                  <c:pt idx="20">
                    <c:v>1.915434655058696E-3</c:v>
                  </c:pt>
                  <c:pt idx="21">
                    <c:v>1.8061626147756649E-3</c:v>
                  </c:pt>
                  <c:pt idx="22">
                    <c:v>2.206556623439685E-3</c:v>
                  </c:pt>
                  <c:pt idx="23">
                    <c:v>2.8288182751047067E-3</c:v>
                  </c:pt>
                  <c:pt idx="24">
                    <c:v>2.9799323234940755E-3</c:v>
                  </c:pt>
                  <c:pt idx="25">
                    <c:v>3.0554152472301575E-3</c:v>
                  </c:pt>
                  <c:pt idx="26">
                    <c:v>2.4689171344722642E-3</c:v>
                  </c:pt>
                  <c:pt idx="27">
                    <c:v>2.5460191204695181E-3</c:v>
                  </c:pt>
                  <c:pt idx="28">
                    <c:v>2.5302609722054345E-3</c:v>
                  </c:pt>
                  <c:pt idx="29">
                    <c:v>2.9009550655379121E-3</c:v>
                  </c:pt>
                  <c:pt idx="30">
                    <c:v>2.7157985394762299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yVal>
            <c:numRef>
              <c:f>'[Figure3 toxoflavin.xlsx]NPB6_Herbaspirillum'!$C$10:$AG$10</c:f>
              <c:numCache>
                <c:formatCode>General</c:formatCode>
                <c:ptCount val="31"/>
                <c:pt idx="0">
                  <c:v>9.2966668307781219E-2</c:v>
                </c:pt>
                <c:pt idx="1">
                  <c:v>9.2500001192092896E-2</c:v>
                </c:pt>
                <c:pt idx="2">
                  <c:v>9.1866667071978256E-2</c:v>
                </c:pt>
                <c:pt idx="3">
                  <c:v>9.086667001247406E-2</c:v>
                </c:pt>
                <c:pt idx="4">
                  <c:v>9.1300000747044877E-2</c:v>
                </c:pt>
                <c:pt idx="5">
                  <c:v>9.0833333631356553E-2</c:v>
                </c:pt>
                <c:pt idx="6">
                  <c:v>9.1300000747044877E-2</c:v>
                </c:pt>
                <c:pt idx="7">
                  <c:v>9.1099999845027924E-2</c:v>
                </c:pt>
                <c:pt idx="8">
                  <c:v>9.1600000858306885E-2</c:v>
                </c:pt>
                <c:pt idx="9">
                  <c:v>9.1799999276796981E-2</c:v>
                </c:pt>
                <c:pt idx="10">
                  <c:v>9.0466665724913284E-2</c:v>
                </c:pt>
                <c:pt idx="11">
                  <c:v>9.1066665947437286E-2</c:v>
                </c:pt>
                <c:pt idx="12">
                  <c:v>9.0500002106030777E-2</c:v>
                </c:pt>
                <c:pt idx="13">
                  <c:v>9.0966664254665375E-2</c:v>
                </c:pt>
                <c:pt idx="14">
                  <c:v>9.1966666281223297E-2</c:v>
                </c:pt>
                <c:pt idx="15">
                  <c:v>9.2533332606156662E-2</c:v>
                </c:pt>
                <c:pt idx="16">
                  <c:v>9.1566666960716248E-2</c:v>
                </c:pt>
                <c:pt idx="17">
                  <c:v>9.1833333174387619E-2</c:v>
                </c:pt>
                <c:pt idx="18">
                  <c:v>9.1633334755897522E-2</c:v>
                </c:pt>
                <c:pt idx="19">
                  <c:v>9.1333332161108657E-2</c:v>
                </c:pt>
                <c:pt idx="20">
                  <c:v>9.1066665947437286E-2</c:v>
                </c:pt>
                <c:pt idx="21">
                  <c:v>9.1166667640209198E-2</c:v>
                </c:pt>
                <c:pt idx="22">
                  <c:v>9.1333332161108657E-2</c:v>
                </c:pt>
                <c:pt idx="23">
                  <c:v>9.1333332161108657E-2</c:v>
                </c:pt>
                <c:pt idx="24">
                  <c:v>9.1599998374780014E-2</c:v>
                </c:pt>
                <c:pt idx="25">
                  <c:v>9.1466667751471206E-2</c:v>
                </c:pt>
                <c:pt idx="26">
                  <c:v>9.1166667640209198E-2</c:v>
                </c:pt>
                <c:pt idx="27">
                  <c:v>9.1366666058699295E-2</c:v>
                </c:pt>
                <c:pt idx="28">
                  <c:v>9.0933335324128464E-2</c:v>
                </c:pt>
                <c:pt idx="29">
                  <c:v>9.1266666849454239E-2</c:v>
                </c:pt>
                <c:pt idx="30">
                  <c:v>9.0933332840601608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6610-1B47-8CCD-C0C2BCC3DD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7005056"/>
        <c:axId val="135078672"/>
      </c:scatterChart>
      <c:valAx>
        <c:axId val="117005056"/>
        <c:scaling>
          <c:orientation val="minMax"/>
          <c:max val="32"/>
          <c:min val="0"/>
        </c:scaling>
        <c:delete val="0"/>
        <c:axPos val="b"/>
        <c:majorTickMark val="cross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35078672"/>
        <c:crosses val="autoZero"/>
        <c:crossBetween val="midCat"/>
      </c:valAx>
      <c:valAx>
        <c:axId val="135078672"/>
        <c:scaling>
          <c:orientation val="minMax"/>
        </c:scaling>
        <c:delete val="0"/>
        <c:axPos val="l"/>
        <c:numFmt formatCode="General" sourceLinked="1"/>
        <c:majorTickMark val="cross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17005056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100"/>
              <a:t>NPB9 (Acidovorax)</a:t>
            </a:r>
            <a:endParaRPr lang="ja-JP" sz="1100"/>
          </a:p>
        </c:rich>
      </c:tx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scatterChart>
        <c:scatterStyle val="smoothMarker"/>
        <c:varyColors val="0"/>
        <c:ser>
          <c:idx val="0"/>
          <c:order val="0"/>
          <c:tx>
            <c:strRef>
              <c:f>'[Figure3 toxoflavin.xlsx]NPB9_Acidovorax'!$B$9</c:f>
              <c:strCache>
                <c:ptCount val="1"/>
                <c:pt idx="0">
                  <c:v>-Tox</c:v>
                </c:pt>
              </c:strCache>
            </c:strRef>
          </c:tx>
          <c:spPr>
            <a:ln w="158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7"/>
            <c:spPr>
              <a:pattFill prst="pct50">
                <a:fgClr>
                  <a:schemeClr val="tx1"/>
                </a:fgClr>
                <a:bgClr>
                  <a:schemeClr val="bg1"/>
                </a:bgClr>
              </a:patt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Figure3 toxoflavin.xlsx]NPB9_Acidovorax'!$C$12:$AG$12</c:f>
                <c:numCache>
                  <c:formatCode>General</c:formatCode>
                  <c:ptCount val="31"/>
                  <c:pt idx="0">
                    <c:v>4.3205094526126684E-4</c:v>
                  </c:pt>
                  <c:pt idx="1">
                    <c:v>7.13363911747739E-4</c:v>
                  </c:pt>
                  <c:pt idx="2">
                    <c:v>6.9442181711444585E-4</c:v>
                  </c:pt>
                  <c:pt idx="3">
                    <c:v>1.0984838592608347E-3</c:v>
                  </c:pt>
                  <c:pt idx="4">
                    <c:v>1.9949926483973481E-3</c:v>
                  </c:pt>
                  <c:pt idx="5">
                    <c:v>1.5326038952804414E-3</c:v>
                  </c:pt>
                  <c:pt idx="6">
                    <c:v>2.1312487018366006E-3</c:v>
                  </c:pt>
                  <c:pt idx="7">
                    <c:v>6.4807584310919055E-4</c:v>
                  </c:pt>
                  <c:pt idx="8">
                    <c:v>2.6132220244579193E-3</c:v>
                  </c:pt>
                  <c:pt idx="9">
                    <c:v>2.046132305031422E-3</c:v>
                  </c:pt>
                  <c:pt idx="10">
                    <c:v>1.267546986982604E-3</c:v>
                  </c:pt>
                  <c:pt idx="11">
                    <c:v>2.9238486432146315E-3</c:v>
                  </c:pt>
                  <c:pt idx="12">
                    <c:v>2.2514278539493321E-3</c:v>
                  </c:pt>
                  <c:pt idx="13">
                    <c:v>3.3289961375352647E-3</c:v>
                  </c:pt>
                  <c:pt idx="14">
                    <c:v>4.6911136678801993E-3</c:v>
                  </c:pt>
                  <c:pt idx="15">
                    <c:v>2.9948008711448808E-3</c:v>
                  </c:pt>
                  <c:pt idx="16">
                    <c:v>4.1287641540226541E-3</c:v>
                  </c:pt>
                  <c:pt idx="17">
                    <c:v>2.3366847121981966E-3</c:v>
                  </c:pt>
                  <c:pt idx="18">
                    <c:v>6.2940836843791573E-3</c:v>
                  </c:pt>
                  <c:pt idx="19">
                    <c:v>5.3989680956915802E-3</c:v>
                  </c:pt>
                  <c:pt idx="20">
                    <c:v>4.0052570278607926E-3</c:v>
                  </c:pt>
                  <c:pt idx="21">
                    <c:v>5.6416873329090721E-3</c:v>
                  </c:pt>
                  <c:pt idx="22">
                    <c:v>1.2190797178124328E-2</c:v>
                  </c:pt>
                  <c:pt idx="23">
                    <c:v>9.1076312363155103E-3</c:v>
                  </c:pt>
                  <c:pt idx="24">
                    <c:v>4.6089172460337911E-3</c:v>
                  </c:pt>
                  <c:pt idx="25">
                    <c:v>3.3865833370251932E-3</c:v>
                  </c:pt>
                  <c:pt idx="26">
                    <c:v>9.9612673448033467E-3</c:v>
                  </c:pt>
                  <c:pt idx="27">
                    <c:v>1.3644130901653463E-2</c:v>
                  </c:pt>
                  <c:pt idx="28">
                    <c:v>1.0378195961789778E-2</c:v>
                  </c:pt>
                  <c:pt idx="29">
                    <c:v>8.0404645133987582E-3</c:v>
                  </c:pt>
                  <c:pt idx="30">
                    <c:v>6.8241444568160718E-3</c:v>
                  </c:pt>
                </c:numCache>
              </c:numRef>
            </c:plus>
            <c:minus>
              <c:numRef>
                <c:f>'[Figure3 toxoflavin.xlsx]NPB9_Acidovorax'!$C$12:$AG$12</c:f>
                <c:numCache>
                  <c:formatCode>General</c:formatCode>
                  <c:ptCount val="31"/>
                  <c:pt idx="0">
                    <c:v>4.3205094526126684E-4</c:v>
                  </c:pt>
                  <c:pt idx="1">
                    <c:v>7.13363911747739E-4</c:v>
                  </c:pt>
                  <c:pt idx="2">
                    <c:v>6.9442181711444585E-4</c:v>
                  </c:pt>
                  <c:pt idx="3">
                    <c:v>1.0984838592608347E-3</c:v>
                  </c:pt>
                  <c:pt idx="4">
                    <c:v>1.9949926483973481E-3</c:v>
                  </c:pt>
                  <c:pt idx="5">
                    <c:v>1.5326038952804414E-3</c:v>
                  </c:pt>
                  <c:pt idx="6">
                    <c:v>2.1312487018366006E-3</c:v>
                  </c:pt>
                  <c:pt idx="7">
                    <c:v>6.4807584310919055E-4</c:v>
                  </c:pt>
                  <c:pt idx="8">
                    <c:v>2.6132220244579193E-3</c:v>
                  </c:pt>
                  <c:pt idx="9">
                    <c:v>2.046132305031422E-3</c:v>
                  </c:pt>
                  <c:pt idx="10">
                    <c:v>1.267546986982604E-3</c:v>
                  </c:pt>
                  <c:pt idx="11">
                    <c:v>2.9238486432146315E-3</c:v>
                  </c:pt>
                  <c:pt idx="12">
                    <c:v>2.2514278539493321E-3</c:v>
                  </c:pt>
                  <c:pt idx="13">
                    <c:v>3.3289961375352647E-3</c:v>
                  </c:pt>
                  <c:pt idx="14">
                    <c:v>4.6911136678801993E-3</c:v>
                  </c:pt>
                  <c:pt idx="15">
                    <c:v>2.9948008711448808E-3</c:v>
                  </c:pt>
                  <c:pt idx="16">
                    <c:v>4.1287641540226541E-3</c:v>
                  </c:pt>
                  <c:pt idx="17">
                    <c:v>2.3366847121981966E-3</c:v>
                  </c:pt>
                  <c:pt idx="18">
                    <c:v>6.2940836843791573E-3</c:v>
                  </c:pt>
                  <c:pt idx="19">
                    <c:v>5.3989680956915802E-3</c:v>
                  </c:pt>
                  <c:pt idx="20">
                    <c:v>4.0052570278607926E-3</c:v>
                  </c:pt>
                  <c:pt idx="21">
                    <c:v>5.6416873329090721E-3</c:v>
                  </c:pt>
                  <c:pt idx="22">
                    <c:v>1.2190797178124328E-2</c:v>
                  </c:pt>
                  <c:pt idx="23">
                    <c:v>9.1076312363155103E-3</c:v>
                  </c:pt>
                  <c:pt idx="24">
                    <c:v>4.6089172460337911E-3</c:v>
                  </c:pt>
                  <c:pt idx="25">
                    <c:v>3.3865833370251932E-3</c:v>
                  </c:pt>
                  <c:pt idx="26">
                    <c:v>9.9612673448033467E-3</c:v>
                  </c:pt>
                  <c:pt idx="27">
                    <c:v>1.3644130901653463E-2</c:v>
                  </c:pt>
                  <c:pt idx="28">
                    <c:v>1.0378195961789778E-2</c:v>
                  </c:pt>
                  <c:pt idx="29">
                    <c:v>8.0404645133987582E-3</c:v>
                  </c:pt>
                  <c:pt idx="30">
                    <c:v>6.824144456816071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yVal>
            <c:numRef>
              <c:f>'[Figure3 toxoflavin.xlsx]NPB9_Acidovorax'!$C$9:$AG$9</c:f>
              <c:numCache>
                <c:formatCode>General</c:formatCode>
                <c:ptCount val="31"/>
                <c:pt idx="0">
                  <c:v>9.4599999487400055E-2</c:v>
                </c:pt>
                <c:pt idx="1">
                  <c:v>9.4633335868517562E-2</c:v>
                </c:pt>
                <c:pt idx="2">
                  <c:v>9.6666663885116577E-2</c:v>
                </c:pt>
                <c:pt idx="3">
                  <c:v>0.13759999970595041</c:v>
                </c:pt>
                <c:pt idx="4">
                  <c:v>0.17299999793370566</c:v>
                </c:pt>
                <c:pt idx="5">
                  <c:v>0.1929666648308436</c:v>
                </c:pt>
                <c:pt idx="6">
                  <c:v>0.23926666378974915</c:v>
                </c:pt>
                <c:pt idx="7">
                  <c:v>0.289000004529953</c:v>
                </c:pt>
                <c:pt idx="8">
                  <c:v>0.3528333306312561</c:v>
                </c:pt>
                <c:pt idx="9">
                  <c:v>0.40060000618298847</c:v>
                </c:pt>
                <c:pt idx="10">
                  <c:v>0.4456999997297923</c:v>
                </c:pt>
                <c:pt idx="11">
                  <c:v>0.49413334329922992</c:v>
                </c:pt>
                <c:pt idx="12">
                  <c:v>0.52843332290649414</c:v>
                </c:pt>
                <c:pt idx="13">
                  <c:v>0.59356667598088586</c:v>
                </c:pt>
                <c:pt idx="14">
                  <c:v>0.6251999934514364</c:v>
                </c:pt>
                <c:pt idx="15">
                  <c:v>0.65126665433247888</c:v>
                </c:pt>
                <c:pt idx="16">
                  <c:v>0.68390001853307092</c:v>
                </c:pt>
                <c:pt idx="17">
                  <c:v>0.71160000562667847</c:v>
                </c:pt>
                <c:pt idx="18">
                  <c:v>0.73443333307902015</c:v>
                </c:pt>
                <c:pt idx="19">
                  <c:v>0.75803333520889282</c:v>
                </c:pt>
                <c:pt idx="20">
                  <c:v>0.77603334188461304</c:v>
                </c:pt>
                <c:pt idx="21">
                  <c:v>0.79023333390553796</c:v>
                </c:pt>
                <c:pt idx="22">
                  <c:v>0.80796666940053308</c:v>
                </c:pt>
                <c:pt idx="23">
                  <c:v>0.81913332144419349</c:v>
                </c:pt>
                <c:pt idx="24">
                  <c:v>0.82813332478205359</c:v>
                </c:pt>
                <c:pt idx="25">
                  <c:v>0.81913332144419349</c:v>
                </c:pt>
                <c:pt idx="26">
                  <c:v>0.83179998397827148</c:v>
                </c:pt>
                <c:pt idx="27">
                  <c:v>0.89643335342407227</c:v>
                </c:pt>
                <c:pt idx="28">
                  <c:v>0.90140000979105628</c:v>
                </c:pt>
                <c:pt idx="29">
                  <c:v>0.91593333085378015</c:v>
                </c:pt>
                <c:pt idx="30">
                  <c:v>0.9183666706085205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55D0-9745-98DC-04C79E94954B}"/>
            </c:ext>
          </c:extLst>
        </c:ser>
        <c:ser>
          <c:idx val="1"/>
          <c:order val="1"/>
          <c:tx>
            <c:strRef>
              <c:f>'[Figure3 toxoflavin.xlsx]NPB9_Acidovorax'!$B$10</c:f>
              <c:strCache>
                <c:ptCount val="1"/>
                <c:pt idx="0">
                  <c:v>+Tox</c:v>
                </c:pt>
              </c:strCache>
            </c:strRef>
          </c:tx>
          <c:spPr>
            <a:ln w="15875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Figure3 toxoflavin.xlsx]NPB9_Acidovorax'!$C$13:$AG$13</c:f>
                <c:numCache>
                  <c:formatCode>General</c:formatCode>
                  <c:ptCount val="31"/>
                  <c:pt idx="0">
                    <c:v>3.2954506734330247E-3</c:v>
                  </c:pt>
                  <c:pt idx="1">
                    <c:v>3.4315552973864E-3</c:v>
                  </c:pt>
                  <c:pt idx="2">
                    <c:v>2.887904908743506E-3</c:v>
                  </c:pt>
                  <c:pt idx="3">
                    <c:v>3.5798814235292603E-3</c:v>
                  </c:pt>
                  <c:pt idx="4">
                    <c:v>3.299832311858941E-3</c:v>
                  </c:pt>
                  <c:pt idx="5">
                    <c:v>3.2934251074929108E-3</c:v>
                  </c:pt>
                  <c:pt idx="6">
                    <c:v>3.1633299326624229E-3</c:v>
                  </c:pt>
                  <c:pt idx="7">
                    <c:v>3.3320003837338462E-3</c:v>
                  </c:pt>
                  <c:pt idx="8">
                    <c:v>3.1930489058609006E-3</c:v>
                  </c:pt>
                  <c:pt idx="9">
                    <c:v>3.1137682687527317E-3</c:v>
                  </c:pt>
                  <c:pt idx="10">
                    <c:v>3.227312901481494E-3</c:v>
                  </c:pt>
                  <c:pt idx="11">
                    <c:v>3.2724427516891779E-3</c:v>
                  </c:pt>
                  <c:pt idx="12">
                    <c:v>2.7980152834690447E-3</c:v>
                  </c:pt>
                  <c:pt idx="13">
                    <c:v>3.0800447904135511E-3</c:v>
                  </c:pt>
                  <c:pt idx="14">
                    <c:v>2.7207021769769632E-3</c:v>
                  </c:pt>
                  <c:pt idx="15">
                    <c:v>3.0594104075125205E-3</c:v>
                  </c:pt>
                  <c:pt idx="16">
                    <c:v>3.2967998571205837E-3</c:v>
                  </c:pt>
                  <c:pt idx="17">
                    <c:v>2.948822012584573E-3</c:v>
                  </c:pt>
                  <c:pt idx="18">
                    <c:v>3.1379389382386572E-3</c:v>
                  </c:pt>
                  <c:pt idx="19">
                    <c:v>3.0800447904135511E-3</c:v>
                  </c:pt>
                  <c:pt idx="20">
                    <c:v>3.0554152472301575E-3</c:v>
                  </c:pt>
                  <c:pt idx="21">
                    <c:v>3.9370049765915741E-3</c:v>
                  </c:pt>
                  <c:pt idx="22">
                    <c:v>4.3058116252323655E-3</c:v>
                  </c:pt>
                  <c:pt idx="23">
                    <c:v>5.570359228412986E-3</c:v>
                  </c:pt>
                  <c:pt idx="24">
                    <c:v>6.4240878775674226E-3</c:v>
                  </c:pt>
                  <c:pt idx="25">
                    <c:v>2.2902742384004374E-2</c:v>
                  </c:pt>
                  <c:pt idx="26">
                    <c:v>2.792040331075343E-2</c:v>
                  </c:pt>
                  <c:pt idx="27">
                    <c:v>2.211022732680373E-2</c:v>
                  </c:pt>
                  <c:pt idx="28">
                    <c:v>2.6480847871594784E-2</c:v>
                  </c:pt>
                  <c:pt idx="29">
                    <c:v>3.888932827755729E-2</c:v>
                  </c:pt>
                  <c:pt idx="30">
                    <c:v>4.650206269784081E-2</c:v>
                  </c:pt>
                </c:numCache>
              </c:numRef>
            </c:plus>
            <c:minus>
              <c:numRef>
                <c:f>'[Figure3 toxoflavin.xlsx]NPB9_Acidovorax'!$C$13:$AG$13</c:f>
                <c:numCache>
                  <c:formatCode>General</c:formatCode>
                  <c:ptCount val="31"/>
                  <c:pt idx="0">
                    <c:v>3.2954506734330247E-3</c:v>
                  </c:pt>
                  <c:pt idx="1">
                    <c:v>3.4315552973864E-3</c:v>
                  </c:pt>
                  <c:pt idx="2">
                    <c:v>2.887904908743506E-3</c:v>
                  </c:pt>
                  <c:pt idx="3">
                    <c:v>3.5798814235292603E-3</c:v>
                  </c:pt>
                  <c:pt idx="4">
                    <c:v>3.299832311858941E-3</c:v>
                  </c:pt>
                  <c:pt idx="5">
                    <c:v>3.2934251074929108E-3</c:v>
                  </c:pt>
                  <c:pt idx="6">
                    <c:v>3.1633299326624229E-3</c:v>
                  </c:pt>
                  <c:pt idx="7">
                    <c:v>3.3320003837338462E-3</c:v>
                  </c:pt>
                  <c:pt idx="8">
                    <c:v>3.1930489058609006E-3</c:v>
                  </c:pt>
                  <c:pt idx="9">
                    <c:v>3.1137682687527317E-3</c:v>
                  </c:pt>
                  <c:pt idx="10">
                    <c:v>3.227312901481494E-3</c:v>
                  </c:pt>
                  <c:pt idx="11">
                    <c:v>3.2724427516891779E-3</c:v>
                  </c:pt>
                  <c:pt idx="12">
                    <c:v>2.7980152834690447E-3</c:v>
                  </c:pt>
                  <c:pt idx="13">
                    <c:v>3.0800447904135511E-3</c:v>
                  </c:pt>
                  <c:pt idx="14">
                    <c:v>2.7207021769769632E-3</c:v>
                  </c:pt>
                  <c:pt idx="15">
                    <c:v>3.0594104075125205E-3</c:v>
                  </c:pt>
                  <c:pt idx="16">
                    <c:v>3.2967998571205837E-3</c:v>
                  </c:pt>
                  <c:pt idx="17">
                    <c:v>2.948822012584573E-3</c:v>
                  </c:pt>
                  <c:pt idx="18">
                    <c:v>3.1379389382386572E-3</c:v>
                  </c:pt>
                  <c:pt idx="19">
                    <c:v>3.0800447904135511E-3</c:v>
                  </c:pt>
                  <c:pt idx="20">
                    <c:v>3.0554152472301575E-3</c:v>
                  </c:pt>
                  <c:pt idx="21">
                    <c:v>3.9370049765915741E-3</c:v>
                  </c:pt>
                  <c:pt idx="22">
                    <c:v>4.3058116252323655E-3</c:v>
                  </c:pt>
                  <c:pt idx="23">
                    <c:v>5.570359228412986E-3</c:v>
                  </c:pt>
                  <c:pt idx="24">
                    <c:v>6.4240878775674226E-3</c:v>
                  </c:pt>
                  <c:pt idx="25">
                    <c:v>2.2902742384004374E-2</c:v>
                  </c:pt>
                  <c:pt idx="26">
                    <c:v>2.792040331075343E-2</c:v>
                  </c:pt>
                  <c:pt idx="27">
                    <c:v>2.211022732680373E-2</c:v>
                  </c:pt>
                  <c:pt idx="28">
                    <c:v>2.6480847871594784E-2</c:v>
                  </c:pt>
                  <c:pt idx="29">
                    <c:v>3.888932827755729E-2</c:v>
                  </c:pt>
                  <c:pt idx="30">
                    <c:v>4.65020626978408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yVal>
            <c:numRef>
              <c:f>'[Figure3 toxoflavin.xlsx]NPB9_Acidovorax'!$C$10:$AG$10</c:f>
              <c:numCache>
                <c:formatCode>General</c:formatCode>
                <c:ptCount val="31"/>
                <c:pt idx="0">
                  <c:v>9.4500000278155014E-2</c:v>
                </c:pt>
                <c:pt idx="1">
                  <c:v>9.2066667973995209E-2</c:v>
                </c:pt>
                <c:pt idx="2">
                  <c:v>9.1899998486042023E-2</c:v>
                </c:pt>
                <c:pt idx="3">
                  <c:v>9.0433334310849503E-2</c:v>
                </c:pt>
                <c:pt idx="4">
                  <c:v>9.046666820844014E-2</c:v>
                </c:pt>
                <c:pt idx="5">
                  <c:v>9.0600001315275833E-2</c:v>
                </c:pt>
                <c:pt idx="6">
                  <c:v>9.0900001426537827E-2</c:v>
                </c:pt>
                <c:pt idx="7">
                  <c:v>9.1633334755897522E-2</c:v>
                </c:pt>
                <c:pt idx="8">
                  <c:v>9.086666752894719E-2</c:v>
                </c:pt>
                <c:pt idx="9">
                  <c:v>9.0966669221719101E-2</c:v>
                </c:pt>
                <c:pt idx="10">
                  <c:v>9.06333327293396E-2</c:v>
                </c:pt>
                <c:pt idx="11">
                  <c:v>9.0566667417685195E-2</c:v>
                </c:pt>
                <c:pt idx="12">
                  <c:v>9.0366666515668229E-2</c:v>
                </c:pt>
                <c:pt idx="13">
                  <c:v>9.0600001315275833E-2</c:v>
                </c:pt>
                <c:pt idx="14">
                  <c:v>9.0533333520094558E-2</c:v>
                </c:pt>
                <c:pt idx="15">
                  <c:v>9.0799999733765915E-2</c:v>
                </c:pt>
                <c:pt idx="16">
                  <c:v>9.0766668319702148E-2</c:v>
                </c:pt>
                <c:pt idx="17">
                  <c:v>9.0533333520094558E-2</c:v>
                </c:pt>
                <c:pt idx="18">
                  <c:v>9.0999998152256012E-2</c:v>
                </c:pt>
                <c:pt idx="19">
                  <c:v>9.0600001315275833E-2</c:v>
                </c:pt>
                <c:pt idx="20">
                  <c:v>9.0566667417685195E-2</c:v>
                </c:pt>
                <c:pt idx="21">
                  <c:v>9.1799999276796981E-2</c:v>
                </c:pt>
                <c:pt idx="22">
                  <c:v>9.2800001303354904E-2</c:v>
                </c:pt>
                <c:pt idx="23">
                  <c:v>9.5266665021578475E-2</c:v>
                </c:pt>
                <c:pt idx="24">
                  <c:v>9.8533334831396743E-2</c:v>
                </c:pt>
                <c:pt idx="25">
                  <c:v>0.11473333338896434</c:v>
                </c:pt>
                <c:pt idx="26">
                  <c:v>0.12433333198229472</c:v>
                </c:pt>
                <c:pt idx="27">
                  <c:v>0.16233333448568979</c:v>
                </c:pt>
                <c:pt idx="28">
                  <c:v>0.19433333476384482</c:v>
                </c:pt>
                <c:pt idx="29">
                  <c:v>0.21810000141461691</c:v>
                </c:pt>
                <c:pt idx="30">
                  <c:v>0.2639333258072535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55D0-9745-98DC-04C79E94954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7005056"/>
        <c:axId val="135078672"/>
      </c:scatterChart>
      <c:valAx>
        <c:axId val="117005056"/>
        <c:scaling>
          <c:orientation val="minMax"/>
          <c:max val="32"/>
          <c:min val="0"/>
        </c:scaling>
        <c:delete val="0"/>
        <c:axPos val="b"/>
        <c:majorTickMark val="cross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35078672"/>
        <c:crosses val="autoZero"/>
        <c:crossBetween val="midCat"/>
      </c:valAx>
      <c:valAx>
        <c:axId val="135078672"/>
        <c:scaling>
          <c:orientation val="minMax"/>
        </c:scaling>
        <c:delete val="0"/>
        <c:axPos val="l"/>
        <c:numFmt formatCode="General" sourceLinked="1"/>
        <c:majorTickMark val="cross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17005056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Sheet1!$A$2:$A$21</cx:f>
        <cx:lvl ptCount="20">
          <cx:pt idx="0">Mock</cx:pt>
          <cx:pt idx="1">Mock</cx:pt>
          <cx:pt idx="2">Mock</cx:pt>
          <cx:pt idx="3">Mock</cx:pt>
          <cx:pt idx="4">Mock</cx:pt>
          <cx:pt idx="5">Mock</cx:pt>
          <cx:pt idx="6">Mock</cx:pt>
          <cx:pt idx="7">Mock</cx:pt>
          <cx:pt idx="8">Mock</cx:pt>
          <cx:pt idx="9">Mock</cx:pt>
          <cx:pt idx="10">BB1</cx:pt>
          <cx:pt idx="11">BB1</cx:pt>
          <cx:pt idx="12">BB1</cx:pt>
          <cx:pt idx="13">BB1</cx:pt>
          <cx:pt idx="14">BB1</cx:pt>
          <cx:pt idx="15">BB1</cx:pt>
          <cx:pt idx="16">BB1</cx:pt>
          <cx:pt idx="17">BB1</cx:pt>
          <cx:pt idx="18">BB1</cx:pt>
          <cx:pt idx="19">BB1</cx:pt>
        </cx:lvl>
      </cx:strDim>
      <cx:numDim type="val">
        <cx:f>Sheet1!$B$2:$B$21</cx:f>
        <cx:lvl ptCount="20" formatCode="G/標準">
          <cx:pt idx="0">11.6</cx:pt>
          <cx:pt idx="1">4.5</cx:pt>
          <cx:pt idx="2">9.4000000000000004</cx:pt>
          <cx:pt idx="3">13.6</cx:pt>
          <cx:pt idx="4">7.2999999999999998</cx:pt>
          <cx:pt idx="5">6.0999999999999996</cx:pt>
          <cx:pt idx="6">8.3000000000000007</cx:pt>
          <cx:pt idx="7">2.5</cx:pt>
          <cx:pt idx="8">9.9000000000000004</cx:pt>
          <cx:pt idx="9">5.5</cx:pt>
          <cx:pt idx="10">11.5</cx:pt>
          <cx:pt idx="11">6.2000000000000002</cx:pt>
          <cx:pt idx="12">8</cx:pt>
          <cx:pt idx="13">10.800000000000001</cx:pt>
          <cx:pt idx="14">4.2000000000000002</cx:pt>
          <cx:pt idx="15">5</cx:pt>
          <cx:pt idx="16">3.2000000000000002</cx:pt>
          <cx:pt idx="17">14.199999999999999</cx:pt>
          <cx:pt idx="18">3.3999999999999999</cx:pt>
          <cx:pt idx="19">2.7999999999999998</cx:pt>
        </cx:lvl>
      </cx:numDim>
    </cx:data>
  </cx:chartData>
  <cx:chart>
    <cx:plotArea>
      <cx:plotAreaRegion>
        <cx:series layoutId="boxWhisker" uniqueId="{CE0C7DAF-1606-4EC2-9861-25F48614DDED}">
          <cx:tx>
            <cx:txData>
              <cx:f>Sheet1!$B$1</cx:f>
              <cx:v>Shoot.length</cx:v>
            </cx:txData>
          </cx:tx>
          <cx:spPr>
            <a:solidFill>
              <a:schemeClr val="bg1">
                <a:lumMod val="75000"/>
              </a:schemeClr>
            </a:solidFill>
            <a:ln w="15875">
              <a:solidFill>
                <a:schemeClr val="tx1"/>
              </a:solidFill>
            </a:ln>
          </cx:spPr>
          <cx:dataId val="0"/>
          <cx:layoutPr>
            <cx:visibility meanLine="0" meanMarker="1" nonoutliers="1" outliers="1"/>
            <cx:statistics quartileMethod="exclusive"/>
          </cx:layoutPr>
        </cx:series>
      </cx:plotAreaRegion>
      <cx:axis id="0">
        <cx:catScaling gapWidth="1"/>
        <cx:majorTickMarks type="cross"/>
        <cx:tickLabels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1600" b="0" i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16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majorTickMarks type="cross"/>
        <cx:tickLabels/>
        <cx:numFmt formatCode="#,##0.0_);[赤](#,##0.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C04FA-ECFD-9F45-8912-C6E5182D79BC}" type="datetimeFigureOut">
              <a:rPr kumimoji="1" lang="ja-JP" altLang="en-US" smtClean="0"/>
              <a:t>2022/5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55B8C-70EB-004A-9905-50E702F6B8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77582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C04FA-ECFD-9F45-8912-C6E5182D79BC}" type="datetimeFigureOut">
              <a:rPr kumimoji="1" lang="ja-JP" altLang="en-US" smtClean="0"/>
              <a:t>2022/5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55B8C-70EB-004A-9905-50E702F6B8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2730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C04FA-ECFD-9F45-8912-C6E5182D79BC}" type="datetimeFigureOut">
              <a:rPr kumimoji="1" lang="ja-JP" altLang="en-US" smtClean="0"/>
              <a:t>2022/5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55B8C-70EB-004A-9905-50E702F6B8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72246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C04FA-ECFD-9F45-8912-C6E5182D79BC}" type="datetimeFigureOut">
              <a:rPr kumimoji="1" lang="ja-JP" altLang="en-US" smtClean="0"/>
              <a:t>2022/5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55B8C-70EB-004A-9905-50E702F6B8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25659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C04FA-ECFD-9F45-8912-C6E5182D79BC}" type="datetimeFigureOut">
              <a:rPr kumimoji="1" lang="ja-JP" altLang="en-US" smtClean="0"/>
              <a:t>2022/5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55B8C-70EB-004A-9905-50E702F6B8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02524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C04FA-ECFD-9F45-8912-C6E5182D79BC}" type="datetimeFigureOut">
              <a:rPr kumimoji="1" lang="ja-JP" altLang="en-US" smtClean="0"/>
              <a:t>2022/5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55B8C-70EB-004A-9905-50E702F6B8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55629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C04FA-ECFD-9F45-8912-C6E5182D79BC}" type="datetimeFigureOut">
              <a:rPr kumimoji="1" lang="ja-JP" altLang="en-US" smtClean="0"/>
              <a:t>2022/5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55B8C-70EB-004A-9905-50E702F6B8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1213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C04FA-ECFD-9F45-8912-C6E5182D79BC}" type="datetimeFigureOut">
              <a:rPr kumimoji="1" lang="ja-JP" altLang="en-US" smtClean="0"/>
              <a:t>2022/5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55B8C-70EB-004A-9905-50E702F6B8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76970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C04FA-ECFD-9F45-8912-C6E5182D79BC}" type="datetimeFigureOut">
              <a:rPr kumimoji="1" lang="ja-JP" altLang="en-US" smtClean="0"/>
              <a:t>2022/5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55B8C-70EB-004A-9905-50E702F6B8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0014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C04FA-ECFD-9F45-8912-C6E5182D79BC}" type="datetimeFigureOut">
              <a:rPr kumimoji="1" lang="ja-JP" altLang="en-US" smtClean="0"/>
              <a:t>2022/5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55B8C-70EB-004A-9905-50E702F6B8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552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C04FA-ECFD-9F45-8912-C6E5182D79BC}" type="datetimeFigureOut">
              <a:rPr kumimoji="1" lang="ja-JP" altLang="en-US" smtClean="0"/>
              <a:t>2022/5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55B8C-70EB-004A-9905-50E702F6B8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21314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4C04FA-ECFD-9F45-8912-C6E5182D79BC}" type="datetimeFigureOut">
              <a:rPr kumimoji="1" lang="ja-JP" altLang="en-US" smtClean="0"/>
              <a:t>2022/5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355B8C-70EB-004A-9905-50E702F6B8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4003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microsoft.com/office/2014/relationships/chartEx" Target="../charts/chartEx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C4FB7765-F22C-884E-8EAF-4AC6D3A4871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76057697"/>
              </p:ext>
            </p:extLst>
          </p:nvPr>
        </p:nvGraphicFramePr>
        <p:xfrm>
          <a:off x="844395" y="2498881"/>
          <a:ext cx="252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C9946283-685E-D243-9657-280CEDCA07D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34160697"/>
              </p:ext>
            </p:extLst>
          </p:nvPr>
        </p:nvGraphicFramePr>
        <p:xfrm>
          <a:off x="3492475" y="2498881"/>
          <a:ext cx="252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E3FBB92-00B2-F34E-8778-0790DAD11782}"/>
              </a:ext>
            </a:extLst>
          </p:cNvPr>
          <p:cNvSpPr txBox="1"/>
          <p:nvPr/>
        </p:nvSpPr>
        <p:spPr>
          <a:xfrm rot="16200000">
            <a:off x="257332" y="3327819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OD600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DCEDC4C-8E22-C845-8FF8-8C12B055DEA3}"/>
              </a:ext>
            </a:extLst>
          </p:cNvPr>
          <p:cNvSpPr txBox="1"/>
          <p:nvPr/>
        </p:nvSpPr>
        <p:spPr>
          <a:xfrm>
            <a:off x="2951868" y="4583668"/>
            <a:ext cx="1035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ime (h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BD10BC9-1315-3D41-9DDD-B3DA60171AB5}"/>
              </a:ext>
            </a:extLst>
          </p:cNvPr>
          <p:cNvSpPr txBox="1"/>
          <p:nvPr/>
        </p:nvSpPr>
        <p:spPr>
          <a:xfrm>
            <a:off x="421290" y="5318030"/>
            <a:ext cx="6133757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. Bacterial growth of NPB6 and NPB9 in liquid LB medium containing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toxoflavi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ja-JP" altLang="ja-JP" sz="14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Herbaspirillum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(NPB6) and </a:t>
            </a:r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Acidovorax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(NPB9) isolates obtained from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Nipponbare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rice seeds inoculated with SDW were cultivated in liquid LB medium containing 0.1 mM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toxoflavi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. The growth of each isolate was measured as OD600 every hour. Error bars represent standard deviation (n = 3). The experiments were repeated twice with similar results.</a:t>
            </a:r>
            <a:endParaRPr lang="ja-JP" altLang="ja-JP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3560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F8B34BF-BEDF-064E-B27D-D4F7DEC734EE}"/>
              </a:ext>
            </a:extLst>
          </p:cNvPr>
          <p:cNvSpPr txBox="1"/>
          <p:nvPr/>
        </p:nvSpPr>
        <p:spPr>
          <a:xfrm>
            <a:off x="389158" y="5641588"/>
            <a:ext cx="613375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. Growth of rice plants after inoculation with 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dispersa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BB1.</a:t>
            </a:r>
            <a:endParaRPr lang="ja-JP" altLang="ja-JP" sz="14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Nipponbare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rice seeds were inoculated with 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dispersa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B1 (OD</a:t>
            </a:r>
            <a:r>
              <a:rPr lang="en-US" altLang="ja-JP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of 0.004) and SDW (mock). (A) Mock- and BB1-inoculated rice plants at 7 dpi. (B) Box plot of the shoot length of inoculated plants at 7 dpi. No statistically significant differences were observed between groups (Student’s t-test, 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&lt; 0.05, n = 10). The experiments were repeated twice with similar results.</a:t>
            </a:r>
            <a:endParaRPr lang="ja-JP" altLang="ja-JP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3" name="グラフ 2">
                <a:extLst>
                  <a:ext uri="{FF2B5EF4-FFF2-40B4-BE49-F238E27FC236}">
                    <a16:creationId xmlns:a16="http://schemas.microsoft.com/office/drawing/2014/main" id="{0359F1C1-6297-4C56-AA42-A6C7941B177F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914531918"/>
                  </p:ext>
                </p:extLst>
              </p:nvPr>
            </p:nvGraphicFramePr>
            <p:xfrm>
              <a:off x="3624201" y="2414197"/>
              <a:ext cx="2563813" cy="26289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"/>
              </a:graphicData>
            </a:graphic>
          </p:graphicFrame>
        </mc:Choice>
        <mc:Fallback xmlns="">
          <p:pic>
            <p:nvPicPr>
              <p:cNvPr id="3" name="グラフ 2">
                <a:extLst>
                  <a:ext uri="{FF2B5EF4-FFF2-40B4-BE49-F238E27FC236}">
                    <a16:creationId xmlns:a16="http://schemas.microsoft.com/office/drawing/2014/main" id="{0359F1C1-6297-4C56-AA42-A6C7941B177F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624201" y="2414197"/>
                <a:ext cx="2563813" cy="2628900"/>
              </a:xfrm>
              <a:prstGeom prst="rect">
                <a:avLst/>
              </a:prstGeom>
            </p:spPr>
          </p:pic>
        </mc:Fallback>
      </mc:AlternateContent>
      <p:pic>
        <p:nvPicPr>
          <p:cNvPr id="5" name="図 4">
            <a:extLst>
              <a:ext uri="{FF2B5EF4-FFF2-40B4-BE49-F238E27FC236}">
                <a16:creationId xmlns:a16="http://schemas.microsoft.com/office/drawing/2014/main" id="{75E8FC3B-E3D3-9A4B-A397-DCA3312664B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325" t="8785" r="6822" b="23991"/>
          <a:stretch/>
        </p:blipFill>
        <p:spPr>
          <a:xfrm>
            <a:off x="745589" y="2342100"/>
            <a:ext cx="2321168" cy="2368124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5E65611-B912-354F-8C3B-3D875998C575}"/>
              </a:ext>
            </a:extLst>
          </p:cNvPr>
          <p:cNvSpPr txBox="1"/>
          <p:nvPr/>
        </p:nvSpPr>
        <p:spPr>
          <a:xfrm rot="16200000">
            <a:off x="2840595" y="3474608"/>
            <a:ext cx="129554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hoot length (cm)</a:t>
            </a:r>
            <a:endParaRPr kumimoji="1"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AF89805-C726-AA41-B955-2ED4F69255C8}"/>
              </a:ext>
            </a:extLst>
          </p:cNvPr>
          <p:cNvSpPr txBox="1"/>
          <p:nvPr/>
        </p:nvSpPr>
        <p:spPr>
          <a:xfrm>
            <a:off x="485438" y="198540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8A41CA3-60E8-B045-8C9D-61F0E0CC720E}"/>
              </a:ext>
            </a:extLst>
          </p:cNvPr>
          <p:cNvSpPr txBox="1"/>
          <p:nvPr/>
        </p:nvSpPr>
        <p:spPr>
          <a:xfrm>
            <a:off x="3357563" y="196899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40E38301-5F2F-3047-B274-79D4C8F9C9CC}"/>
              </a:ext>
            </a:extLst>
          </p:cNvPr>
          <p:cNvSpPr txBox="1"/>
          <p:nvPr/>
        </p:nvSpPr>
        <p:spPr>
          <a:xfrm>
            <a:off x="2135480" y="4753967"/>
            <a:ext cx="5245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B1</a:t>
            </a:r>
            <a:endParaRPr kumimoji="1"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C6BE319-7D2F-6D47-B0AB-8B0DAF6A404F}"/>
              </a:ext>
            </a:extLst>
          </p:cNvPr>
          <p:cNvSpPr txBox="1"/>
          <p:nvPr/>
        </p:nvSpPr>
        <p:spPr>
          <a:xfrm>
            <a:off x="1249032" y="4753967"/>
            <a:ext cx="6126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kumimoji="1"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072A5641-D40A-C84B-A4DA-5B76DD32D499}"/>
              </a:ext>
            </a:extLst>
          </p:cNvPr>
          <p:cNvCxnSpPr/>
          <p:nvPr/>
        </p:nvCxnSpPr>
        <p:spPr>
          <a:xfrm>
            <a:off x="4497572" y="2626242"/>
            <a:ext cx="107388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448F378-EE59-4346-96EB-C0765154D33E}"/>
              </a:ext>
            </a:extLst>
          </p:cNvPr>
          <p:cNvSpPr txBox="1"/>
          <p:nvPr/>
        </p:nvSpPr>
        <p:spPr>
          <a:xfrm>
            <a:off x="4808598" y="2343921"/>
            <a:ext cx="5229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. s.</a:t>
            </a:r>
            <a:endParaRPr kumimoji="1"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46128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53</TotalTime>
  <Words>195</Words>
  <Application>Microsoft Macintosh PowerPoint</Application>
  <PresentationFormat>A4 210 x 297 mm</PresentationFormat>
  <Paragraphs>14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香西　雄介</dc:creator>
  <cp:lastModifiedBy>香西　雄介</cp:lastModifiedBy>
  <cp:revision>41</cp:revision>
  <dcterms:created xsi:type="dcterms:W3CDTF">2022-01-12T00:05:40Z</dcterms:created>
  <dcterms:modified xsi:type="dcterms:W3CDTF">2022-05-24T08:55:40Z</dcterms:modified>
</cp:coreProperties>
</file>